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924" y="-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6002704"/>
            <a:ext cx="864096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. </a:t>
            </a:r>
            <a:r>
              <a:rPr lang="fr-FR" sz="11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fr-FR" sz="11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entification of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atur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496T669 as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ysoPC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16:0) (cas 9008-30-4);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standard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lecul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u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al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p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ull MS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omatogram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dl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ull MS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ectra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ttom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S/MS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ectra</a:t>
            </a:r>
            <a:endParaRPr lang="fr-FR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96173" y="260648"/>
            <a:ext cx="6751655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196173" y="2276872"/>
            <a:ext cx="6751655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6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196173" y="4149280"/>
            <a:ext cx="6751655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40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Gaelle</dc:creator>
  <cp:lastModifiedBy>GRISON Stephane</cp:lastModifiedBy>
  <cp:revision>10</cp:revision>
  <dcterms:created xsi:type="dcterms:W3CDTF">2014-11-17T10:21:09Z</dcterms:created>
  <dcterms:modified xsi:type="dcterms:W3CDTF">2016-07-07T13:31:13Z</dcterms:modified>
</cp:coreProperties>
</file>